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1AC91-CA6E-448E-99A8-4CDC676D5D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C3DB3-26B5-478D-B945-5849970C5C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C989B-F382-4D90-A6B4-89741923AE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34013-B877-425C-BEEA-55D3BAD897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A9BBB-3372-4AC0-A2AE-F65BB12686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01947-E257-47A8-A505-48EBDCDFCB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5CFE0-0D5D-4DEA-A20B-A7A6A3A079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2A3C33-0A66-4F8C-9107-41D3B58999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F15F86-A6B4-4546-8439-DFD40CA349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3BBB7-9D6B-4D4C-84EA-A09C11BB54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F9A3B-C4C0-476E-A919-4FA8F6375A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CDCFE-C380-47F5-BD66-1C2B35B08D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0D2ACF-1E70-452C-8449-540F8CB97F16}" type="slidenum">
              <a:rPr b="0" lang="ja-JP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304920" y="76320"/>
            <a:ext cx="8381880" cy="64674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1295280" y="228600"/>
            <a:ext cx="69343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e prognosis of patients divided by the average of SA of CA-SSR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007000" y="3962520"/>
            <a:ext cx="164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orter allele leng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05120" y="441972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905120" y="45720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743560" y="4294080"/>
            <a:ext cx="110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gt;=18 (n=119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743560" y="4446720"/>
            <a:ext cx="110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=17 (n=180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752480" y="4267080"/>
            <a:ext cx="2057400" cy="457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400800" y="3581280"/>
            <a:ext cx="1066680" cy="45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477120" y="2895480"/>
            <a:ext cx="1066680" cy="45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582560" y="6351480"/>
            <a:ext cx="45028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rvival data were available for 299 informative cas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24T22:09:22Z</dcterms:created>
  <dc:creator>UT User</dc:creator>
  <dc:description/>
  <dc:language>en-US</dc:language>
  <cp:lastModifiedBy>MASAHARU</cp:lastModifiedBy>
  <dcterms:modified xsi:type="dcterms:W3CDTF">2007-02-09T06:59:26Z</dcterms:modified>
  <cp:revision>4</cp:revision>
  <dc:subject/>
  <dc:title>Slide 1</dc:title>
</cp:coreProperties>
</file>